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CE811-33D0-4D01-BADF-29E1AA48B1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D84DF-7D03-44A7-917E-951D15ACB9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7F82B-DAFF-496E-B291-456F8DBF4D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A9063-DAEE-4104-A472-EB60D79548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175C9-24EB-485C-955A-29187C8ECA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C30EB-8574-4DC4-ADCF-56955125AD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E3DF4-B14C-410D-B7E9-B5FBD8F213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58F93-BF96-4834-BB45-1B58C46602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F6F6D-37C4-4B5B-BE07-A7F4CF3412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D3909-A169-4F51-B05D-C6A8F8288F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7FD1D-D898-49B1-BACB-B542851A20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5603F-006C-49B2-AD80-8A681DF2EB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C94E69-D18D-457E-A22F-BB2537E6ECAB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79280" y="5513400"/>
            <a:ext cx="88934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2 Fig. Significant upregulation of target genes by  antimiR-142-3p-mediated inhibition in human breast cancer cell lines.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qPCR using ABI TaqMan probes for 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ROCK2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(MDA-MB-231) or 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FLT1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(MCF-7) expression normalized to 18S rRNA expression after transfection with antimiR-142-3p and control miRNA precursor (see main manuscript and Götte et al. (2010) for details). N=8, error bars = SEM, *P&lt;0.05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5"/>
          <p:cNvGraphicFramePr/>
          <p:nvPr/>
        </p:nvGraphicFramePr>
        <p:xfrm>
          <a:off x="826920" y="44280"/>
          <a:ext cx="7129800" cy="5330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26920" y="44280"/>
                    <a:ext cx="7129800" cy="5330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5T06:18:10Z</dcterms:created>
  <dc:creator>Martin Götte</dc:creator>
  <dc:description/>
  <dc:language>en-US</dc:language>
  <cp:lastModifiedBy>Prof. Dr. Martin Götte</cp:lastModifiedBy>
  <dcterms:modified xsi:type="dcterms:W3CDTF">2015-11-16T14:50:36Z</dcterms:modified>
  <cp:revision>12</cp:revision>
  <dc:subject/>
  <dc:title>Folie 1</dc:title>
</cp:coreProperties>
</file>